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9CB24-38C3-79AE-2143-B5A4997B13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99DB5B-DF42-1541-44CF-3F61E39A5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856A1-1796-545A-7D31-88EC9FD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55CEF-B2A3-5F27-B027-00200D0AD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60859-C5BE-06D1-8758-1F187520E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9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ECF11-A83B-D09D-C275-915B44E71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C86E07-10B5-7AA2-3B2B-FE4F57D89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911B5-00C0-1446-85C3-0EC0ADDD9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C1CFA-FE5E-33F7-232F-18561756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467E6-5E77-3BEF-7C8F-5761EA782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99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8ADA38-CA22-F565-59CB-E903BC44DE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D79850-A514-A337-16F1-DC9F6A8DB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3337C-DCF0-E098-31AF-8D6604B1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6D9F1-299F-EFDB-ACBF-F15A6B9F9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955DA-12FD-3D3F-F878-34D2B3040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71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065DE-7CB2-0F44-DE31-AFB83B512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2F680-8700-2237-B3EB-7DE5D3341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94465-5D26-4516-F59F-84B0C0544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FD60C-4059-427F-8FDA-CCF367030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CCE32A-744A-A6C1-330F-02120334B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97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1285E-B7E4-CAE3-DEBA-06C31FF1E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4A9AFA-BAA5-AE9F-ED25-45CAF2E07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0221E-6FB9-05E4-424D-129DD2927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EE191-65D9-C83C-AD19-02759C4E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D03BF-04F6-07D1-26C6-685F81E08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63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5C5B8-748D-0E5C-D206-BE20CE2E2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A3992-F537-D149-9443-21E6E1A9E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CB345D-F217-0F19-A5B1-63519F973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52FF1-476C-69D6-9E22-8DB38FD0D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6B846-A922-D283-4E36-1AFBB28C3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00C72-5B36-1104-D905-43487AD7A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23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D4E0A-9352-A89F-EB56-D5F03C30D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BEBE4-0CDB-EC76-8B01-2C745E367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3C7DDD-0E06-6F00-6DF4-4308479A2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C4E999-A01E-CCB9-F332-4271BB9850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7CE03-4E44-050C-8AE6-9D545B4FD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776E9F-4A03-FD05-18DE-5F5E08DC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F7AD89-9A47-DC38-88E3-6C1FA8FA1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031AC4-0A9B-EADD-688F-5887D56AB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66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FE0B1-B762-2DDD-ADF3-EB45536A4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DCD74-5AB9-2F73-3BC5-C9FED58D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C970FC-920F-8195-A2D7-AAEFA5D5A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E5CCDC-E77E-AE92-C425-D85A09A53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4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BBA306-BF16-0F48-630C-5C3D8389C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8326BF-C759-403C-8E09-3FC656E7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EEC72-1126-30F8-6FDF-FC25FD9D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04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EF9AA-0C99-3BF3-2885-CF9A2C5D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18E782-BB65-C57D-5DAB-93DE74CD9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48E3B3-E707-02F8-847C-B2252F0202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0C773-332F-2D40-9FEE-8C830D50C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DCD5C9-4D3A-B576-46C8-22B56A0A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200D-D482-E961-272D-E9E4EA952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59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F4072-2451-CF96-96D4-7D391EA5E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549CD9-4D06-2E2B-8655-3E5F011FCC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5EC0B-FB46-6313-A40A-D699EF6BC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9ED5D0-39B1-547C-055D-C5DB413A7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A4C80-C9E1-1F9D-34DD-C3E592EE4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9F1D8-CCBF-F0A0-464B-CF8CE7A01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2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E1F0BC-1C6E-E892-7635-F793AE5E8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DA04E3-3D7A-A023-5277-A781CF819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3CDA6-D7E6-B2F4-1F66-B839DA480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701F3-7979-8DAC-C6C7-626D985765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A4BAF-559A-6EF5-0C0F-D273B763E7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491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dark&#10;&#10;Description automatically generated">
            <a:extLst>
              <a:ext uri="{FF2B5EF4-FFF2-40B4-BE49-F238E27FC236}">
                <a16:creationId xmlns:a16="http://schemas.microsoft.com/office/drawing/2014/main" id="{944D8D8D-3828-04F3-0CFB-020447137B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018" y="417397"/>
            <a:ext cx="3855253" cy="2281799"/>
          </a:xfrm>
          <a:prstGeom prst="rect">
            <a:avLst/>
          </a:prstGeom>
        </p:spPr>
      </p:pic>
      <p:pic>
        <p:nvPicPr>
          <p:cNvPr id="8" name="Picture 7" descr="A picture containing invertebrate, coelenterate, jellyfish&#10;&#10;Description automatically generated">
            <a:extLst>
              <a:ext uri="{FF2B5EF4-FFF2-40B4-BE49-F238E27FC236}">
                <a16:creationId xmlns:a16="http://schemas.microsoft.com/office/drawing/2014/main" id="{506E9181-EFC3-4158-5EE1-F493188B70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42643" y="460689"/>
            <a:ext cx="3832030" cy="2241157"/>
          </a:xfrm>
          <a:prstGeom prst="rect">
            <a:avLst/>
          </a:prstGeom>
        </p:spPr>
      </p:pic>
      <p:pic>
        <p:nvPicPr>
          <p:cNvPr id="10" name="Picture 9" descr="A picture containing jellyfish&#10;&#10;Description automatically generated">
            <a:extLst>
              <a:ext uri="{FF2B5EF4-FFF2-40B4-BE49-F238E27FC236}">
                <a16:creationId xmlns:a16="http://schemas.microsoft.com/office/drawing/2014/main" id="{03CDF6C9-05E6-147E-13CF-45406CFB60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92043" y="446427"/>
            <a:ext cx="3890091" cy="225276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E5E0B17-25EA-1333-7847-A3C2B6982D57}"/>
              </a:ext>
            </a:extLst>
          </p:cNvPr>
          <p:cNvSpPr txBox="1"/>
          <p:nvPr/>
        </p:nvSpPr>
        <p:spPr>
          <a:xfrm>
            <a:off x="421380" y="2683758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01702_Brain 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33B7555-C8A7-235B-6B8C-CD12C14C1E7C}"/>
              </a:ext>
            </a:extLst>
          </p:cNvPr>
          <p:cNvSpPr txBox="1"/>
          <p:nvPr/>
        </p:nvSpPr>
        <p:spPr>
          <a:xfrm>
            <a:off x="9060856" y="2699196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01702_Brain 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A3CC7E8-2A8B-B22D-BAD8-CFBE418E13C4}"/>
              </a:ext>
            </a:extLst>
          </p:cNvPr>
          <p:cNvSpPr txBox="1"/>
          <p:nvPr/>
        </p:nvSpPr>
        <p:spPr>
          <a:xfrm>
            <a:off x="5082424" y="2699196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01702_Brain 2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753236D2-C94A-4786-B605-681D5F9CD02D}"/>
              </a:ext>
            </a:extLst>
          </p:cNvPr>
          <p:cNvGrpSpPr/>
          <p:nvPr/>
        </p:nvGrpSpPr>
        <p:grpSpPr>
          <a:xfrm>
            <a:off x="60225" y="3187927"/>
            <a:ext cx="12031793" cy="2252770"/>
            <a:chOff x="-1419706" y="3878087"/>
            <a:chExt cx="13494802" cy="2526696"/>
          </a:xfrm>
        </p:grpSpPr>
        <p:pic>
          <p:nvPicPr>
            <p:cNvPr id="19" name="Picture 18" descr="A group of jellyfish in the water&#10;&#10;Description automatically generated with low confidence">
              <a:extLst>
                <a:ext uri="{FF2B5EF4-FFF2-40B4-BE49-F238E27FC236}">
                  <a16:creationId xmlns:a16="http://schemas.microsoft.com/office/drawing/2014/main" id="{3617DD0E-F76E-0C52-227E-2701E511550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1419706" y="3878087"/>
              <a:ext cx="4455677" cy="2526695"/>
            </a:xfrm>
            <a:prstGeom prst="rect">
              <a:avLst/>
            </a:prstGeom>
          </p:spPr>
        </p:pic>
        <p:pic>
          <p:nvPicPr>
            <p:cNvPr id="24" name="Picture 23" descr="A picture containing text, jellyfish, ocean floor&#10;&#10;Description automatically generated">
              <a:extLst>
                <a:ext uri="{FF2B5EF4-FFF2-40B4-BE49-F238E27FC236}">
                  <a16:creationId xmlns:a16="http://schemas.microsoft.com/office/drawing/2014/main" id="{1B85D048-229C-ECEB-6E9A-104AA4D98C6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086054" y="3878088"/>
              <a:ext cx="4489638" cy="2526695"/>
            </a:xfrm>
            <a:prstGeom prst="rect">
              <a:avLst/>
            </a:prstGeom>
          </p:spPr>
        </p:pic>
        <p:pic>
          <p:nvPicPr>
            <p:cNvPr id="26" name="Picture 25" descr="A picture containing jellyfish, image, blurry, ocean floor&#10;&#10;Description automatically generated">
              <a:extLst>
                <a:ext uri="{FF2B5EF4-FFF2-40B4-BE49-F238E27FC236}">
                  <a16:creationId xmlns:a16="http://schemas.microsoft.com/office/drawing/2014/main" id="{DD56F22B-9A87-E706-FCD7-8C7249408B0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619419" y="3878088"/>
              <a:ext cx="4455677" cy="2492734"/>
            </a:xfrm>
            <a:prstGeom prst="rect">
              <a:avLst/>
            </a:prstGeom>
          </p:spPr>
        </p:pic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4755208A-8029-CF88-B3B4-4442B0571263}"/>
              </a:ext>
            </a:extLst>
          </p:cNvPr>
          <p:cNvSpPr txBox="1"/>
          <p:nvPr/>
        </p:nvSpPr>
        <p:spPr>
          <a:xfrm>
            <a:off x="9335004" y="5440696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01958_Brain 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53046B0-847F-92FF-1D71-E758625B6C47}"/>
              </a:ext>
            </a:extLst>
          </p:cNvPr>
          <p:cNvSpPr txBox="1"/>
          <p:nvPr/>
        </p:nvSpPr>
        <p:spPr>
          <a:xfrm>
            <a:off x="821504" y="5410418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01958_Brain 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0EF9F1A-18EA-0C22-D668-0EADEB4C0033}"/>
              </a:ext>
            </a:extLst>
          </p:cNvPr>
          <p:cNvSpPr txBox="1"/>
          <p:nvPr/>
        </p:nvSpPr>
        <p:spPr>
          <a:xfrm>
            <a:off x="4898875" y="5440696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01958_Brain 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1531C85-D9EA-470C-FD81-8E5E7A420C04}"/>
              </a:ext>
            </a:extLst>
          </p:cNvPr>
          <p:cNvSpPr txBox="1"/>
          <p:nvPr/>
        </p:nvSpPr>
        <p:spPr>
          <a:xfrm>
            <a:off x="10580242" y="570725"/>
            <a:ext cx="756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OAN-e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D07B2E3-0300-45AA-1CCC-96D7CD4B368D}"/>
              </a:ext>
            </a:extLst>
          </p:cNvPr>
          <p:cNvSpPr txBox="1"/>
          <p:nvPr/>
        </p:nvSpPr>
        <p:spPr>
          <a:xfrm>
            <a:off x="8694120" y="1558296"/>
            <a:ext cx="733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AN-c1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CEAABFC5-9894-6E21-824A-1688EC901565}"/>
              </a:ext>
            </a:extLst>
          </p:cNvPr>
          <p:cNvCxnSpPr/>
          <p:nvPr/>
        </p:nvCxnSpPr>
        <p:spPr>
          <a:xfrm flipV="1">
            <a:off x="9592038" y="1413951"/>
            <a:ext cx="622534" cy="24993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2645CF08-6203-4E4C-1D63-10A5DBC87E7F}"/>
              </a:ext>
            </a:extLst>
          </p:cNvPr>
          <p:cNvCxnSpPr>
            <a:cxnSpLocks/>
          </p:cNvCxnSpPr>
          <p:nvPr/>
        </p:nvCxnSpPr>
        <p:spPr>
          <a:xfrm flipV="1">
            <a:off x="9222086" y="1294551"/>
            <a:ext cx="0" cy="263618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F4BA97DE-59FD-6AA6-736A-360D333FC55A}"/>
              </a:ext>
            </a:extLst>
          </p:cNvPr>
          <p:cNvSpPr txBox="1"/>
          <p:nvPr/>
        </p:nvSpPr>
        <p:spPr>
          <a:xfrm>
            <a:off x="1152929" y="3991395"/>
            <a:ext cx="756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OAN-e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6EED827-7F9D-F3A0-4324-204B121D59E5}"/>
              </a:ext>
            </a:extLst>
          </p:cNvPr>
          <p:cNvSpPr txBox="1"/>
          <p:nvPr/>
        </p:nvSpPr>
        <p:spPr>
          <a:xfrm>
            <a:off x="5717723" y="3118354"/>
            <a:ext cx="756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OAN-e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BF73D31-7740-4725-BB48-8EFA6672EBB5}"/>
              </a:ext>
            </a:extLst>
          </p:cNvPr>
          <p:cNvSpPr txBox="1"/>
          <p:nvPr/>
        </p:nvSpPr>
        <p:spPr>
          <a:xfrm>
            <a:off x="9720627" y="3197048"/>
            <a:ext cx="756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OAN-e1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9008DD02-A25B-0945-88CE-5841628424B2}"/>
              </a:ext>
            </a:extLst>
          </p:cNvPr>
          <p:cNvCxnSpPr>
            <a:cxnSpLocks/>
          </p:cNvCxnSpPr>
          <p:nvPr/>
        </p:nvCxnSpPr>
        <p:spPr>
          <a:xfrm flipH="1">
            <a:off x="5844209" y="3411872"/>
            <a:ext cx="114174" cy="143598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DCCB63AB-1A26-BCB8-DD60-D21AE7210D68}"/>
              </a:ext>
            </a:extLst>
          </p:cNvPr>
          <p:cNvCxnSpPr>
            <a:cxnSpLocks/>
          </p:cNvCxnSpPr>
          <p:nvPr/>
        </p:nvCxnSpPr>
        <p:spPr>
          <a:xfrm flipH="1">
            <a:off x="9797418" y="3450417"/>
            <a:ext cx="114174" cy="143598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C8161D98-6F52-CFB6-E4D1-B5D9978D2FAA}"/>
              </a:ext>
            </a:extLst>
          </p:cNvPr>
          <p:cNvCxnSpPr>
            <a:cxnSpLocks/>
          </p:cNvCxnSpPr>
          <p:nvPr/>
        </p:nvCxnSpPr>
        <p:spPr>
          <a:xfrm>
            <a:off x="10123626" y="3443793"/>
            <a:ext cx="147245" cy="13169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2D5D5471-8A48-E244-431C-755D242F7EB8}"/>
              </a:ext>
            </a:extLst>
          </p:cNvPr>
          <p:cNvCxnSpPr>
            <a:cxnSpLocks/>
          </p:cNvCxnSpPr>
          <p:nvPr/>
        </p:nvCxnSpPr>
        <p:spPr>
          <a:xfrm>
            <a:off x="6125842" y="3425925"/>
            <a:ext cx="147245" cy="13169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99552180-9E2B-C120-16F1-2F787475E835}"/>
              </a:ext>
            </a:extLst>
          </p:cNvPr>
          <p:cNvSpPr txBox="1"/>
          <p:nvPr/>
        </p:nvSpPr>
        <p:spPr>
          <a:xfrm>
            <a:off x="2671230" y="3916017"/>
            <a:ext cx="4363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9F090C4-29C5-FE4C-E601-69BBCC22A9C9}"/>
              </a:ext>
            </a:extLst>
          </p:cNvPr>
          <p:cNvSpPr txBox="1"/>
          <p:nvPr/>
        </p:nvSpPr>
        <p:spPr>
          <a:xfrm>
            <a:off x="5068335" y="4006534"/>
            <a:ext cx="4363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B22FFE2-75DB-4DE0-07D0-05549BEA104D}"/>
              </a:ext>
            </a:extLst>
          </p:cNvPr>
          <p:cNvSpPr txBox="1"/>
          <p:nvPr/>
        </p:nvSpPr>
        <p:spPr>
          <a:xfrm>
            <a:off x="6574371" y="4131463"/>
            <a:ext cx="4363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CF2E35E-4107-94C1-EA3E-57C1A3D3A1CE}"/>
              </a:ext>
            </a:extLst>
          </p:cNvPr>
          <p:cNvSpPr txBox="1"/>
          <p:nvPr/>
        </p:nvSpPr>
        <p:spPr>
          <a:xfrm>
            <a:off x="8964287" y="4050724"/>
            <a:ext cx="4363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A61D8D8-E8EA-1BC4-4A2B-459F95D57804}"/>
              </a:ext>
            </a:extLst>
          </p:cNvPr>
          <p:cNvSpPr txBox="1"/>
          <p:nvPr/>
        </p:nvSpPr>
        <p:spPr>
          <a:xfrm>
            <a:off x="10820902" y="3949952"/>
            <a:ext cx="4363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244D00B-4184-04CF-3AEA-4E10B5EE325E}"/>
              </a:ext>
            </a:extLst>
          </p:cNvPr>
          <p:cNvSpPr txBox="1"/>
          <p:nvPr/>
        </p:nvSpPr>
        <p:spPr>
          <a:xfrm>
            <a:off x="105110" y="33696"/>
            <a:ext cx="5503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OAN-e1</a:t>
            </a:r>
          </a:p>
        </p:txBody>
      </p:sp>
    </p:spTree>
    <p:extLst>
      <p:ext uri="{BB962C8B-B14F-4D97-AF65-F5344CB8AC3E}">
        <p14:creationId xmlns:p14="http://schemas.microsoft.com/office/powerpoint/2010/main" val="18123622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41</Words>
  <Application>Microsoft Macintosh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uman, Jim</dc:creator>
  <cp:lastModifiedBy>Truman, Jim</cp:lastModifiedBy>
  <cp:revision>7</cp:revision>
  <dcterms:created xsi:type="dcterms:W3CDTF">2022-06-08T22:16:26Z</dcterms:created>
  <dcterms:modified xsi:type="dcterms:W3CDTF">2022-06-08T22:47:00Z</dcterms:modified>
</cp:coreProperties>
</file>